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1" r:id="rId3"/>
    <p:sldId id="272" r:id="rId4"/>
    <p:sldId id="264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4660"/>
  </p:normalViewPr>
  <p:slideViewPr>
    <p:cSldViewPr>
      <p:cViewPr varScale="1">
        <p:scale>
          <a:sx n="94" d="100"/>
          <a:sy n="94" d="100"/>
        </p:scale>
        <p:origin x="-108" y="-12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23AFA4-2039-4A9B-A4DC-987C93C8FD44}" type="datetimeFigureOut">
              <a:rPr lang="en-US" smtClean="0"/>
              <a:pPr/>
              <a:t>6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9555A8-1BB0-48ED-A388-6D30B24251F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106CH</a:t>
            </a:r>
            <a:endParaRPr lang="en-US" dirty="0"/>
          </a:p>
        </p:txBody>
      </p:sp>
      <p:pic>
        <p:nvPicPr>
          <p:cNvPr id="14338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91674" y="1486597"/>
            <a:ext cx="6180595" cy="518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33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524000"/>
            <a:ext cx="2447925" cy="25336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4</a:t>
            </a:r>
          </a:p>
          <a:p>
            <a:r>
              <a:rPr lang="en-US" dirty="0" smtClean="0"/>
              <a:t>% Positive = 14.5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108RR</a:t>
            </a:r>
            <a:endParaRPr lang="en-US" dirty="0"/>
          </a:p>
        </p:txBody>
      </p:sp>
      <p:pic>
        <p:nvPicPr>
          <p:cNvPr id="15362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91668" y="1524000"/>
            <a:ext cx="6295132" cy="533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5363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524001"/>
            <a:ext cx="2224763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9</a:t>
            </a:r>
          </a:p>
          <a:p>
            <a:r>
              <a:rPr lang="en-US" dirty="0" smtClean="0"/>
              <a:t>% Positive = 24.0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109GT</a:t>
            </a:r>
            <a:endParaRPr lang="en-US" dirty="0"/>
          </a:p>
        </p:txBody>
      </p:sp>
      <p:pic>
        <p:nvPicPr>
          <p:cNvPr id="1638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317968" y="1524001"/>
            <a:ext cx="6397407" cy="533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6387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524001"/>
            <a:ext cx="2266317" cy="2362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7</a:t>
            </a:r>
          </a:p>
          <a:p>
            <a:r>
              <a:rPr lang="en-US" dirty="0" smtClean="0"/>
              <a:t>% Positive = 18.4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dirty="0" smtClean="0"/>
              <a:t>111HG</a:t>
            </a:r>
            <a:endParaRPr lang="en-US" dirty="0"/>
          </a:p>
        </p:txBody>
      </p:sp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209800" y="1435662"/>
            <a:ext cx="6477000" cy="5422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0" y="1447800"/>
            <a:ext cx="2083429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6"/>
          <p:cNvSpPr txBox="1"/>
          <p:nvPr/>
        </p:nvSpPr>
        <p:spPr>
          <a:xfrm>
            <a:off x="212728" y="4419600"/>
            <a:ext cx="189014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Stat3: </a:t>
            </a:r>
          </a:p>
          <a:p>
            <a:r>
              <a:rPr lang="en-US" dirty="0" err="1" smtClean="0"/>
              <a:t>Nuc</a:t>
            </a:r>
            <a:r>
              <a:rPr lang="en-US" dirty="0" smtClean="0"/>
              <a:t> OD = 18</a:t>
            </a:r>
          </a:p>
          <a:p>
            <a:r>
              <a:rPr lang="en-US" dirty="0" smtClean="0"/>
              <a:t>% Positive = 29.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26</TotalTime>
  <Words>44</Words>
  <Application>Microsoft Office PowerPoint</Application>
  <PresentationFormat>On-screen Show (4:3)</PresentationFormat>
  <Paragraphs>1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106CH</vt:lpstr>
      <vt:lpstr>108RR</vt:lpstr>
      <vt:lpstr>109GT</vt:lpstr>
      <vt:lpstr>111HG</vt:lpstr>
    </vt:vector>
  </TitlesOfParts>
  <Company>Novartis Pharma A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 Stat3 Stain SH008 Human Sample</dc:title>
  <dc:creator>Lab_HATAKSH1</dc:creator>
  <cp:lastModifiedBy>Hatakeyama, Shinji</cp:lastModifiedBy>
  <cp:revision>62</cp:revision>
  <dcterms:created xsi:type="dcterms:W3CDTF">2012-11-29T15:22:01Z</dcterms:created>
  <dcterms:modified xsi:type="dcterms:W3CDTF">2013-06-10T13:53:28Z</dcterms:modified>
</cp:coreProperties>
</file>